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914400" y="685800"/>
            <a:ext cx="6858000" cy="60149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457200" y="76200"/>
            <a:ext cx="85344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 hormone metabolism and signaling genes differentially expressed between four sub-apical internodes of bioenergy sorghum inbre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.0702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the youngest sub-apical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the oldest internode. Values represent mean expression level of three biological replicates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K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expression level in each row highlighted with blue is lower and highlighted with red is higher. </a:t>
            </a:r>
          </a:p>
        </p:txBody>
      </p:sp>
    </p:spTree>
    <p:extLst>
      <p:ext uri="{BB962C8B-B14F-4D97-AF65-F5344CB8AC3E}">
        <p14:creationId xmlns:p14="http://schemas.microsoft.com/office/powerpoint/2010/main" xmlns="" val="1521264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6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6:22Z</dcterms:modified>
</cp:coreProperties>
</file>